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942"/>
    <p:restoredTop sz="94680"/>
  </p:normalViewPr>
  <p:slideViewPr>
    <p:cSldViewPr snapToGrid="0" snapToObjects="1">
      <p:cViewPr varScale="1">
        <p:scale>
          <a:sx n="84" d="100"/>
          <a:sy n="84" d="100"/>
        </p:scale>
        <p:origin x="84" y="3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59A2BD-5E3B-A94F-934C-A3C5320129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28298B1-212B-584E-A5D3-D56F46BC88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7783B8-F2DE-4747-826D-F1B9CA722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B77A00-E6D5-9B43-A54A-A39C0E874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5254E1-F0FD-604B-8553-315B454F7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746025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FF948F-A671-8B4C-9D31-E2C6AD86B2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0A35B0-7538-E64C-BFEB-4F3D8A960C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2CB0C3-622A-D14F-8500-C41D503029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7484AF-EA1F-194F-9064-21628DBA2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E8F8C2-E977-874A-86FB-0692FDA37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94000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EC009F-E478-E64F-B9CE-1C74169383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F24C7D-FDD1-4243-AB6B-0A1090E276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842D34-A145-3840-8B78-D8CFCFEAA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44193D-223E-794F-9106-6B5329495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4934CD-DC38-5845-B07D-F36D57028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54538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1B5304-C39E-1045-A65E-2F8E5E74D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B41030-555A-3746-9723-292D2C7569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6058E2-8412-AE4E-B940-EF62EB39B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19E458-1E8E-944B-9697-19B2913D9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F7D32D-1662-314C-AEEC-2C8B484B1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63651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0FF9CA-9E8A-8D49-A3A2-29A48235E6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BFD69B-4372-BF4E-A324-64950B3B58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B3E329-2D7E-F44C-BA9B-AC0ECA931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4801F8-B6C1-D745-9BA6-DEC192548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1FF37E-B4CF-1E48-AF80-B4F53234B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044747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27C52A-FB4E-4843-8917-4890831AE8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F7A1A1-9F8F-6346-8662-EC298CA186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6D07A8-B632-4245-A0FF-9624C57419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11AE32-F0DA-014B-B39B-ABAB3E3A6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948750-145F-5849-ABA5-64A23F0D0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B764A8-E83C-584D-9C1B-AF1D16C40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56384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31D46F-9ABE-FD40-8F06-0A9C15BEAA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178E11-472B-BB4B-8530-0C3183E45C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0D484D-1C03-0142-8CCC-1771419C00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022CF9-43BA-304A-AEBB-2E28CD6CEE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0A4FBEC-E17F-EF44-A45C-E023BE2C09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058C39-0279-E244-B46F-59FD96928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BAFB2E-A47B-7F48-8E39-C9C249D7F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FE0493-C94F-504F-A255-C2AE3A551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77389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2FB42-FCDD-A645-A001-0FA054CCEC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E78CCB5-73D4-6440-B9EA-F38566B8B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A2685BC-8A07-264A-A224-124380C61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4250BD-0951-5140-96B3-2BD519D48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15523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733794-A1F1-C846-A9B4-AB385AB76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C3D9FA6-6800-2A4E-AEA3-259D358B1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91CC5F-C6E8-E047-91B4-7DF08AB34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465970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C135D4-3B70-4349-935D-AA0AF58D1B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F32AA7-79B0-D849-9369-68D870D5D9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F36FC5-997E-8445-815A-2E5C1947ED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E53B81-479C-2449-8BF2-FCBE2A0AF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580311-7436-514C-86EF-A7CF69479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34143B-F32F-CD4D-A003-13A3D45E2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232088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B3DF9A-E5BC-9043-9571-4C23CE3486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86BA0F1-E7C1-EA4A-8875-EC28EB83DE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882E7A-CA1A-7243-8A31-803039958D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DC462E-1E53-B242-87D0-C0142F9AA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21AA79-8961-4C44-B6DB-E4E653243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40B3EC-CB3C-504C-A7C0-7C1B192E5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718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B548D7-C861-CD42-A376-210ACBD93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37F90E-EAB9-C24A-8596-398FA6954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0E5580-979E-B547-8064-D1D014D3D3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623839-7E58-A740-9C5B-E5C806A7CB76}" type="datetimeFigureOut">
              <a:rPr lang="en-JP" smtClean="0"/>
              <a:t>04/05/2022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913F8C-2E0A-074C-B16F-80FC7E28CD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95871-64BE-E84E-A348-60AE21C774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FF86D-CF47-6746-9210-DD4CE871564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1948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78A28275-96C7-FB48-95A3-F66CDC54C0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312420" y="480060"/>
            <a:ext cx="18973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Legend </a:t>
            </a:r>
            <a:r>
              <a:rPr kumimoji="1" lang="en-US" altLang="ja-JP" dirty="0"/>
              <a:t>: Raw </a:t>
            </a:r>
            <a:r>
              <a:rPr kumimoji="1" lang="en-US" altLang="ja-JP" dirty="0" err="1" smtClean="0"/>
              <a:t>immunofluoresce</a:t>
            </a:r>
            <a:r>
              <a:rPr kumimoji="1" lang="en-US" altLang="ja-JP" dirty="0" smtClean="0"/>
              <a:t> images </a:t>
            </a:r>
            <a:r>
              <a:rPr kumimoji="1" lang="en-US" altLang="ja-JP" dirty="0"/>
              <a:t>from </a:t>
            </a:r>
            <a:r>
              <a:rPr kumimoji="1" lang="en-US" altLang="ja-JP" dirty="0" smtClean="0"/>
              <a:t>Figure 4A :</a:t>
            </a:r>
            <a:r>
              <a:rPr kumimoji="1" lang="en-US" altLang="ja-JP" dirty="0" err="1" smtClean="0"/>
              <a:t>hTau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560115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jellyfish in the dark&#10;&#10;Description automatically generated with low confidence">
            <a:extLst>
              <a:ext uri="{FF2B5EF4-FFF2-40B4-BE49-F238E27FC236}">
                <a16:creationId xmlns:a16="http://schemas.microsoft.com/office/drawing/2014/main" id="{A6855B5A-027A-3A47-AF65-D7B3A6D68F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312420" y="480060"/>
            <a:ext cx="189738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Legend </a:t>
            </a:r>
            <a:r>
              <a:rPr kumimoji="1" lang="en-US" altLang="ja-JP" dirty="0"/>
              <a:t>: Raw </a:t>
            </a:r>
            <a:r>
              <a:rPr kumimoji="1" lang="en-US" altLang="ja-JP" dirty="0" err="1" smtClean="0"/>
              <a:t>immunofluoresce</a:t>
            </a:r>
            <a:r>
              <a:rPr kumimoji="1" lang="en-US" altLang="ja-JP" dirty="0" smtClean="0"/>
              <a:t> images </a:t>
            </a:r>
            <a:r>
              <a:rPr kumimoji="1" lang="en-US" altLang="ja-JP" dirty="0"/>
              <a:t>from </a:t>
            </a:r>
            <a:r>
              <a:rPr kumimoji="1" lang="en-US" altLang="ja-JP" dirty="0" smtClean="0"/>
              <a:t>Figure 4A :beta3 Tubulin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442236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dark, light, outdoor object, blurry&#10;&#10;Description automatically generated">
            <a:extLst>
              <a:ext uri="{FF2B5EF4-FFF2-40B4-BE49-F238E27FC236}">
                <a16:creationId xmlns:a16="http://schemas.microsoft.com/office/drawing/2014/main" id="{DBE82307-34A6-D242-9F7E-BDEF02CC06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312420" y="480060"/>
            <a:ext cx="189738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Legend </a:t>
            </a:r>
            <a:r>
              <a:rPr kumimoji="1" lang="en-US" altLang="ja-JP" dirty="0"/>
              <a:t>: Raw </a:t>
            </a:r>
            <a:r>
              <a:rPr kumimoji="1" lang="en-US" altLang="ja-JP" dirty="0" err="1" smtClean="0"/>
              <a:t>immunofluoresce</a:t>
            </a:r>
            <a:r>
              <a:rPr kumimoji="1" lang="en-US" altLang="ja-JP" dirty="0" smtClean="0"/>
              <a:t> images </a:t>
            </a:r>
            <a:r>
              <a:rPr kumimoji="1" lang="en-US" altLang="ja-JP" dirty="0"/>
              <a:t>from </a:t>
            </a:r>
            <a:r>
              <a:rPr kumimoji="1" lang="en-US" altLang="ja-JP" dirty="0" smtClean="0"/>
              <a:t>Figure 4A :Dynamin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38794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1</Words>
  <Application>Microsoft Office PowerPoint</Application>
  <PresentationFormat>ワイド画面</PresentationFormat>
  <Paragraphs>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Office Theme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t Guillaud</dc:creator>
  <cp:lastModifiedBy>tetsuya.hori.1970@gmail.com</cp:lastModifiedBy>
  <cp:revision>2</cp:revision>
  <dcterms:created xsi:type="dcterms:W3CDTF">2021-09-10T02:16:20Z</dcterms:created>
  <dcterms:modified xsi:type="dcterms:W3CDTF">2022-04-05T07:10:54Z</dcterms:modified>
</cp:coreProperties>
</file>